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6.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A393FDD-C452-4B28-97E3-C391F0D5F7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A468828-2506-4D54-A5C0-DC17AFEF322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112433F-6B85-4A5D-A7B1-66B316A1DE5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E959F10-59D2-4BD3-A1C6-4F6B2DCF009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4B7AF1D-AA7A-4CD2-923D-9C413C04607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21309A2-E5A3-4C64-A687-58F60072F76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A130776-B15A-49D2-937E-7A6594B7C80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0482983-A51F-42D9-831B-BC0FF559A4B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FEE05F9-6C7F-4669-95E0-44AED65B7FD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D32B624-A169-4EFA-BF85-A36F5A1BFB3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3A1CFF3-E37B-42F1-AF29-6B3CD906F58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F566BA-40F2-4DB9-9F8C-22F14B4EAB8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AT"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AT"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AT"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AT"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AT"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BB7E28-88E7-47E0-9213-214862826193}" type="slidenum">
              <a:rPr b="0" lang="de-AT"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79280" y="3447360"/>
            <a:ext cx="8569440" cy="118908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haracteristics of the qPCR assays applied for analysis of IL6 and iNOS gene expression. Indicated are the accession (Acc.) number and gene name. Using the described primer sequences a specific product of the indicated length, given in base pairs (bp), and melt temperature (Melt temp.) was generated. In order to increase specificity we chose primer, that forced the PCR product to span over exon junctions. Length of intron is indicated (in bp). Primer sequence for HO-1 was taken from Rozen S, and Skaletsky H. Primer3 on the www for general users and for biologist programmers. </a:t>
            </a:r>
            <a:r>
              <a:rPr b="0" i="1" lang="en-US" sz="1200" spc="-1" strike="noStrike">
                <a:solidFill>
                  <a:srgbClr val="000000"/>
                </a:solidFill>
                <a:latin typeface="Arial"/>
              </a:rPr>
              <a:t>Methods Mol Biol</a:t>
            </a:r>
            <a:r>
              <a:rPr b="0" lang="en-US" sz="1200" spc="-1" strike="noStrike">
                <a:solidFill>
                  <a:srgbClr val="000000"/>
                </a:solidFill>
                <a:latin typeface="Arial"/>
              </a:rPr>
              <a:t> 132: 365-386, 2000. </a:t>
            </a:r>
            <a:endParaRPr b="0" lang="en-US" sz="1200" spc="-1" strike="noStrike">
              <a:solidFill>
                <a:srgbClr val="000000"/>
              </a:solidFill>
              <a:latin typeface="Arial"/>
            </a:endParaRPr>
          </a:p>
        </p:txBody>
      </p:sp>
      <p:graphicFrame>
        <p:nvGraphicFramePr>
          <p:cNvPr id="42" name=""/>
          <p:cNvGraphicFramePr/>
          <p:nvPr/>
        </p:nvGraphicFramePr>
        <p:xfrm>
          <a:off x="179280" y="1052640"/>
          <a:ext cx="8640720" cy="2130120"/>
        </p:xfrm>
        <a:graphic>
          <a:graphicData uri="http://schemas.openxmlformats.org/drawingml/2006/table">
            <a:tbl>
              <a:tblPr/>
              <a:tblGrid>
                <a:gridCol w="1122480"/>
                <a:gridCol w="650880"/>
                <a:gridCol w="1879560"/>
                <a:gridCol w="630360"/>
                <a:gridCol w="628560"/>
                <a:gridCol w="938160"/>
                <a:gridCol w="1435320"/>
                <a:gridCol w="1355400"/>
              </a:tblGrid>
              <a:tr h="55080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Acc. number</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Targe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rimer sequence</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osition on</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 strand</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roduct length</a:t>
                      </a:r>
                      <a:br>
                        <a:rPr sz="1000"/>
                      </a:br>
                      <a:r>
                        <a:rPr b="0" lang="en-GB" sz="1000" spc="-1" strike="noStrike">
                          <a:solidFill>
                            <a:srgbClr val="000000"/>
                          </a:solidFill>
                          <a:latin typeface="Calibri"/>
                          <a:ea typeface="Times New Roman"/>
                        </a:rPr>
                        <a:t>(bp)</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roduct</a:t>
                      </a:r>
                      <a:br>
                        <a:rPr sz="1000"/>
                      </a:br>
                      <a:r>
                        <a:rPr b="0" lang="en-GB" sz="1000" spc="-1" strike="noStrike">
                          <a:solidFill>
                            <a:srgbClr val="000000"/>
                          </a:solidFill>
                          <a:latin typeface="Calibri"/>
                          <a:ea typeface="Times New Roman"/>
                        </a:rPr>
                        <a:t>Melt temp</a:t>
                      </a:r>
                      <a:br>
                        <a:rPr sz="1000"/>
                      </a:br>
                      <a:r>
                        <a:rPr b="0" lang="en-GB" sz="1000" spc="-1" strike="noStrike">
                          <a:solidFill>
                            <a:srgbClr val="000000"/>
                          </a:solidFill>
                          <a:latin typeface="Calibri"/>
                          <a:ea typeface="Times New Roman"/>
                        </a:rPr>
                        <a:t>(°C)</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exon junction in</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Intron size</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bp)</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398520">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NM_012589.1</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IL6</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Times New Roman"/>
                        </a:rPr>
                        <a:t>CCG GAG AGG AGA CTT CAC AG</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154</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161</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83</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roduc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a:t>
                      </a:r>
                      <a:r>
                        <a:rPr b="0" lang="en-GB" sz="1000" spc="-1" strike="noStrike">
                          <a:solidFill>
                            <a:srgbClr val="000000"/>
                          </a:solidFill>
                          <a:latin typeface="Calibri"/>
                          <a:ea typeface="Times New Roman"/>
                        </a:rPr>
                        <a:t>870</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3985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Times New Roman"/>
                        </a:rPr>
                        <a:t>ACA GTG CAT CAT CGC TGT TC</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314</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r h="398520">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NM_012611.3</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iNO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Times New Roman"/>
                        </a:rPr>
                        <a:t>AGG CAA GCC CTC ACC TAC T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274</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161</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89</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produc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rowSpan="2">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a:t>
                      </a:r>
                      <a:r>
                        <a:rPr b="0" lang="en-GB" sz="1000" spc="-1" strike="noStrike">
                          <a:solidFill>
                            <a:srgbClr val="000000"/>
                          </a:solidFill>
                          <a:latin typeface="Calibri"/>
                          <a:ea typeface="Times New Roman"/>
                        </a:rPr>
                        <a:t>1800</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398520">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90000" rIns="90000" tIns="46800" bIns="46800" anchor="t">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ourier New"/>
                          <a:ea typeface="Times New Roman"/>
                        </a:rPr>
                        <a:t>GTG GGG TTG TTG CTG AAC T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434</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800" spc="-1" strike="noStrike">
                        <a:solidFill>
                          <a:srgbClr val="000000"/>
                        </a:solidFill>
                        <a:latin typeface="Arial"/>
                      </a:endParaRPr>
                    </a:p>
                  </a:txBody>
                  <a:tcPr anchor="t" marL="90000" marR="90000">
                    <a:lnL>
                      <a:noFill/>
                    </a:lnL>
                    <a:lnR>
                      <a:noFill/>
                    </a:lnR>
                    <a:lnT>
                      <a:noFill/>
                    </a:lnT>
                    <a:lnB>
                      <a:noFill/>
                    </a:lnB>
                    <a:solidFill>
                      <a:srgbClr val="729fcf"/>
                    </a:solidFill>
                  </a:tcPr>
                </a:tc>
              </a:tr>
            </a:tbl>
          </a:graphicData>
        </a:graphic>
      </p:graphicFrame>
      <p:sp>
        <p:nvSpPr>
          <p:cNvPr id="43" name=""/>
          <p:cNvSpPr/>
          <p:nvPr/>
        </p:nvSpPr>
        <p:spPr>
          <a:xfrm>
            <a:off x="108000" y="548640"/>
            <a:ext cx="8569440" cy="27648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table 1</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4" name="Picture 1" descr=""/>
          <p:cNvPicPr/>
          <p:nvPr/>
        </p:nvPicPr>
        <p:blipFill>
          <a:blip r:embed="rId1"/>
          <a:stretch/>
        </p:blipFill>
        <p:spPr>
          <a:xfrm>
            <a:off x="338040" y="1049400"/>
            <a:ext cx="2678040" cy="1606320"/>
          </a:xfrm>
          <a:prstGeom prst="rect">
            <a:avLst/>
          </a:prstGeom>
          <a:ln w="0">
            <a:noFill/>
          </a:ln>
        </p:spPr>
      </p:pic>
      <p:pic>
        <p:nvPicPr>
          <p:cNvPr id="45" name="Picture 7" descr=""/>
          <p:cNvPicPr/>
          <p:nvPr/>
        </p:nvPicPr>
        <p:blipFill>
          <a:blip r:embed="rId2"/>
          <a:stretch/>
        </p:blipFill>
        <p:spPr>
          <a:xfrm>
            <a:off x="3117960" y="1049400"/>
            <a:ext cx="2678040" cy="1612800"/>
          </a:xfrm>
          <a:prstGeom prst="rect">
            <a:avLst/>
          </a:prstGeom>
          <a:ln w="0">
            <a:noFill/>
          </a:ln>
        </p:spPr>
      </p:pic>
      <p:pic>
        <p:nvPicPr>
          <p:cNvPr id="46" name="Picture 28" descr=""/>
          <p:cNvPicPr/>
          <p:nvPr/>
        </p:nvPicPr>
        <p:blipFill>
          <a:blip r:embed="rId3"/>
          <a:stretch/>
        </p:blipFill>
        <p:spPr>
          <a:xfrm>
            <a:off x="5897520" y="1047600"/>
            <a:ext cx="2678040" cy="1609920"/>
          </a:xfrm>
          <a:prstGeom prst="rect">
            <a:avLst/>
          </a:prstGeom>
          <a:ln w="0">
            <a:noFill/>
          </a:ln>
        </p:spPr>
      </p:pic>
      <p:pic>
        <p:nvPicPr>
          <p:cNvPr id="47" name="Picture 10" descr=""/>
          <p:cNvPicPr/>
          <p:nvPr/>
        </p:nvPicPr>
        <p:blipFill>
          <a:blip r:embed="rId4"/>
          <a:stretch/>
        </p:blipFill>
        <p:spPr>
          <a:xfrm>
            <a:off x="326880" y="2903400"/>
            <a:ext cx="2678400" cy="1609920"/>
          </a:xfrm>
          <a:prstGeom prst="rect">
            <a:avLst/>
          </a:prstGeom>
          <a:ln w="0">
            <a:noFill/>
          </a:ln>
        </p:spPr>
      </p:pic>
      <p:pic>
        <p:nvPicPr>
          <p:cNvPr id="48" name="Picture 13" descr=""/>
          <p:cNvPicPr/>
          <p:nvPr/>
        </p:nvPicPr>
        <p:blipFill>
          <a:blip r:embed="rId5"/>
          <a:stretch/>
        </p:blipFill>
        <p:spPr>
          <a:xfrm>
            <a:off x="3108240" y="2906640"/>
            <a:ext cx="2667240" cy="1604880"/>
          </a:xfrm>
          <a:prstGeom prst="rect">
            <a:avLst/>
          </a:prstGeom>
          <a:ln w="0">
            <a:noFill/>
          </a:ln>
        </p:spPr>
      </p:pic>
      <p:pic>
        <p:nvPicPr>
          <p:cNvPr id="49" name="Picture 31" descr=""/>
          <p:cNvPicPr/>
          <p:nvPr/>
        </p:nvPicPr>
        <p:blipFill>
          <a:blip r:embed="rId6"/>
          <a:stretch/>
        </p:blipFill>
        <p:spPr>
          <a:xfrm>
            <a:off x="5881680" y="2903400"/>
            <a:ext cx="2728800" cy="1641600"/>
          </a:xfrm>
          <a:prstGeom prst="rect">
            <a:avLst/>
          </a:prstGeom>
          <a:ln w="0">
            <a:noFill/>
          </a:ln>
        </p:spPr>
      </p:pic>
      <p:sp>
        <p:nvSpPr>
          <p:cNvPr id="50" name=""/>
          <p:cNvSpPr/>
          <p:nvPr/>
        </p:nvSpPr>
        <p:spPr>
          <a:xfrm>
            <a:off x="250920" y="340560"/>
            <a:ext cx="7459560" cy="7333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ea typeface="Times New Roman"/>
              </a:rPr>
              <a:t>Supplementary figure 1</a:t>
            </a:r>
            <a:br>
              <a:rPr sz="1200"/>
            </a:br>
            <a:br>
              <a:rPr sz="1000"/>
            </a:br>
            <a:r>
              <a:rPr b="1" lang="en-US" sz="1000" spc="-1" strike="noStrike">
                <a:solidFill>
                  <a:srgbClr val="000000"/>
                </a:solidFill>
                <a:latin typeface="Arial"/>
                <a:ea typeface="Times New Roman"/>
              </a:rPr>
              <a:t>Assay validation using dilution series</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Times New Roman"/>
              </a:rPr>
              <a:t>IL6</a:t>
            </a:r>
            <a:endParaRPr b="0" lang="en-US" sz="1000" spc="-1" strike="noStrike">
              <a:solidFill>
                <a:srgbClr val="000000"/>
              </a:solidFill>
              <a:latin typeface="Arial"/>
            </a:endParaRPr>
          </a:p>
        </p:txBody>
      </p:sp>
      <p:sp>
        <p:nvSpPr>
          <p:cNvPr id="51" name=""/>
          <p:cNvSpPr/>
          <p:nvPr/>
        </p:nvSpPr>
        <p:spPr>
          <a:xfrm>
            <a:off x="279360" y="2696400"/>
            <a:ext cx="504720" cy="24624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ea typeface="Times New Roman"/>
              </a:rPr>
              <a:t>iNOS</a:t>
            </a:r>
            <a:endParaRPr b="0" lang="en-US" sz="1000" spc="-1" strike="noStrike">
              <a:solidFill>
                <a:srgbClr val="000000"/>
              </a:solidFill>
              <a:latin typeface="Arial"/>
            </a:endParaRPr>
          </a:p>
        </p:txBody>
      </p:sp>
      <p:graphicFrame>
        <p:nvGraphicFramePr>
          <p:cNvPr id="52" name=""/>
          <p:cNvGraphicFramePr/>
          <p:nvPr/>
        </p:nvGraphicFramePr>
        <p:xfrm>
          <a:off x="250920" y="4973760"/>
          <a:ext cx="8569080" cy="1036440"/>
        </p:xfrm>
        <a:graphic>
          <a:graphicData uri="http://schemas.openxmlformats.org/drawingml/2006/table">
            <a:tbl>
              <a:tblPr/>
              <a:tblGrid>
                <a:gridCol w="668160"/>
                <a:gridCol w="1087560"/>
                <a:gridCol w="987480"/>
                <a:gridCol w="592200"/>
                <a:gridCol w="1184040"/>
                <a:gridCol w="1284480"/>
                <a:gridCol w="1677960"/>
                <a:gridCol w="1087200"/>
              </a:tblGrid>
              <a:tr h="55080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Targe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a:t>
                      </a:r>
                      <a:r>
                        <a:rPr b="0" lang="en-GB" sz="1000" spc="-1" strike="noStrike">
                          <a:solidFill>
                            <a:srgbClr val="000000"/>
                          </a:solidFill>
                          <a:latin typeface="Calibri"/>
                          <a:ea typeface="Times New Roman"/>
                        </a:rPr>
                        <a:t>Ct</a:t>
                      </a:r>
                      <a:br>
                        <a:rPr sz="1000"/>
                      </a:br>
                      <a:r>
                        <a:rPr b="0" lang="en-GB" sz="1000" spc="-1" strike="noStrike">
                          <a:solidFill>
                            <a:srgbClr val="000000"/>
                          </a:solidFill>
                          <a:latin typeface="Calibri"/>
                          <a:ea typeface="Times New Roman"/>
                        </a:rPr>
                        <a:t>(RT+ to RT-)</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Detection</a:t>
                      </a:r>
                      <a:br>
                        <a:rPr sz="1000"/>
                      </a:br>
                      <a:r>
                        <a:rPr b="0" lang="en-GB" sz="1000" spc="-1" strike="noStrike">
                          <a:solidFill>
                            <a:srgbClr val="000000"/>
                          </a:solidFill>
                          <a:latin typeface="Calibri"/>
                          <a:ea typeface="Times New Roman"/>
                        </a:rPr>
                        <a:t>method</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slope</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Annealing &amp; Extension</a:t>
                      </a:r>
                      <a:br>
                        <a:rPr sz="1000"/>
                      </a:br>
                      <a:r>
                        <a:rPr b="0" lang="en-GB" sz="1000" spc="-1" strike="noStrike">
                          <a:solidFill>
                            <a:srgbClr val="000000"/>
                          </a:solidFill>
                          <a:latin typeface="Calibri"/>
                          <a:ea typeface="Times New Roman"/>
                        </a:rPr>
                        <a:t>temp (°C)/time (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Data aquisition</a:t>
                      </a:r>
                      <a:br>
                        <a:rPr sz="1000"/>
                      </a:br>
                      <a:r>
                        <a:rPr b="0" lang="en-GB" sz="1000" spc="-1" strike="noStrike">
                          <a:solidFill>
                            <a:srgbClr val="000000"/>
                          </a:solidFill>
                          <a:latin typeface="Calibri"/>
                          <a:ea typeface="Times New Roman"/>
                        </a:rPr>
                        <a:t>temp(°C)/time (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CorrelationCoefficient (Pearsson) R</a:t>
                      </a:r>
                      <a:r>
                        <a:rPr b="0" lang="en-GB" sz="1000" spc="-1" strike="noStrike" baseline="30000">
                          <a:solidFill>
                            <a:srgbClr val="000000"/>
                          </a:solidFill>
                          <a:latin typeface="Calibri"/>
                          <a:ea typeface="Times New Roman"/>
                        </a:rPr>
                        <a:t>2</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verified dynamic range</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24624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IL6</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n.d.</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SYBR</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3.514</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69/10</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78/15</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0.998</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10^6</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246240">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iNO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n.d.</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SYBR</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3.488</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69/10</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78/15</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0.999</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Calibri"/>
                          <a:ea typeface="Times New Roman"/>
                        </a:rPr>
                        <a:t>10^6</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53" name=""/>
          <p:cNvSpPr/>
          <p:nvPr/>
        </p:nvSpPr>
        <p:spPr>
          <a:xfrm>
            <a:off x="244440" y="4563360"/>
            <a:ext cx="8964720" cy="3985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Amplification plot, regression analyses and melt curve analyses of dilution series using PCR product in 1:10 dilution steps from 1:10</a:t>
            </a:r>
            <a:r>
              <a:rPr b="0" lang="en-US" sz="1000" spc="-1" strike="noStrike" baseline="30000">
                <a:solidFill>
                  <a:srgbClr val="000000"/>
                </a:solidFill>
                <a:latin typeface="Arial"/>
                <a:ea typeface="Times New Roman"/>
              </a:rPr>
              <a:t>-5</a:t>
            </a:r>
            <a:r>
              <a:rPr b="0" lang="en-US" sz="1000" spc="-1" strike="noStrike">
                <a:solidFill>
                  <a:srgbClr val="000000"/>
                </a:solidFill>
                <a:latin typeface="Arial"/>
                <a:ea typeface="Times New Roman"/>
              </a:rPr>
              <a:t> to 1:10</a:t>
            </a:r>
            <a:r>
              <a:rPr b="0" lang="en-US" sz="1000" spc="-1" strike="noStrike" baseline="30000">
                <a:solidFill>
                  <a:srgbClr val="000000"/>
                </a:solidFill>
                <a:latin typeface="Arial"/>
                <a:ea typeface="Times New Roman"/>
              </a:rPr>
              <a:t>-10</a:t>
            </a:r>
            <a:r>
              <a:rPr b="0" lang="en-US" sz="1000" spc="-1" strike="noStrike">
                <a:solidFill>
                  <a:srgbClr val="000000"/>
                </a:solidFill>
                <a:latin typeface="Arial"/>
                <a:ea typeface="Times New Roman"/>
              </a:rPr>
              <a:t>. All samples were measured in triplicates.</a:t>
            </a:r>
            <a:endParaRPr b="0" lang="en-US" sz="1000" spc="-1" strike="noStrike">
              <a:solidFill>
                <a:srgbClr val="000000"/>
              </a:solidFill>
              <a:latin typeface="Arial"/>
            </a:endParaRPr>
          </a:p>
        </p:txBody>
      </p:sp>
      <p:sp>
        <p:nvSpPr>
          <p:cNvPr id="54" name=""/>
          <p:cNvSpPr/>
          <p:nvPr/>
        </p:nvSpPr>
        <p:spPr>
          <a:xfrm>
            <a:off x="195120" y="6130080"/>
            <a:ext cx="8425080" cy="55080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he established RT–qPCR Protocol was validated using the indicated detection method and the indicated annealing and extension conditions by performing dilution series with PCR products in 1:10 steps in triplicates. The resulting slope of the regression analysis corresponding to the efficiency of the qPCR as well as the dynamic range for detecting 100% positive of the lowest dilution is indicated.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1-23T17:26:21Z</dcterms:created>
  <dc:creator>LBI</dc:creator>
  <dc:description/>
  <dc:language>en-US</dc:language>
  <cp:lastModifiedBy>LBI</cp:lastModifiedBy>
  <dcterms:modified xsi:type="dcterms:W3CDTF">2013-01-24T10:58:02Z</dcterms:modified>
  <cp:revision>2</cp:revision>
  <dc:subject/>
  <dc:title>Foli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DocumentId">
    <vt:lpwstr>Presentation 1.PPT</vt:lpwstr>
  </property>
  <property fmtid="{D5CDD505-2E9C-101B-9397-08002B2CF9AE}" pid="3" name="DocumentType">
    <vt:lpwstr>Presentation</vt:lpwstr>
  </property>
  <property fmtid="{D5CDD505-2E9C-101B-9397-08002B2CF9AE}" pid="4" name="FileFormat">
    <vt:lpwstr>PPT</vt:lpwstr>
  </property>
  <property fmtid="{D5CDD505-2E9C-101B-9397-08002B2CF9AE}" pid="5" name="TitleName">
    <vt:lpwstr>Presentation 1.PPT</vt:lpwstr>
  </property>
</Properties>
</file>